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33" autoAdjust="0"/>
    <p:restoredTop sz="94660"/>
  </p:normalViewPr>
  <p:slideViewPr>
    <p:cSldViewPr snapToGrid="0">
      <p:cViewPr varScale="1">
        <p:scale>
          <a:sx n="67" d="100"/>
          <a:sy n="67" d="100"/>
        </p:scale>
        <p:origin x="213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970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519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63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942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213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6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569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383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735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151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546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D2492D-570C-4408-97FB-892D523D1152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0160D-5ED0-4178-93A7-A5307D823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448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CCAD907-140B-423B-8D85-3A833448ED8D}"/>
              </a:ext>
            </a:extLst>
          </p:cNvPr>
          <p:cNvSpPr txBox="1"/>
          <p:nvPr/>
        </p:nvSpPr>
        <p:spPr>
          <a:xfrm>
            <a:off x="490325" y="133350"/>
            <a:ext cx="5877350" cy="1144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Absorbance of supernatant (405 nm) from RBC-solution exposed to serially dilute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alat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nom in presence of pre- and post- treatments of 0.5mM Copper Gluconate (CuGluc) and 5mM 2-Hydroxypropyl-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odextrin (HP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) </a:t>
            </a:r>
          </a:p>
        </p:txBody>
      </p:sp>
      <p:pic>
        <p:nvPicPr>
          <p:cNvPr id="5" name="Google Shape;383;g3123ef45bf8_0_0">
            <a:extLst>
              <a:ext uri="{FF2B5EF4-FFF2-40B4-BE49-F238E27FC236}">
                <a16:creationId xmlns:a16="http://schemas.microsoft.com/office/drawing/2014/main" id="{E0D147A7-D0F7-4C19-91CD-652486FAC7CE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490324" y="1562100"/>
            <a:ext cx="5948575" cy="33909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53304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talab</dc:creator>
  <cp:lastModifiedBy>alatalab</cp:lastModifiedBy>
  <cp:revision>1</cp:revision>
  <dcterms:created xsi:type="dcterms:W3CDTF">2024-12-31T03:45:45Z</dcterms:created>
  <dcterms:modified xsi:type="dcterms:W3CDTF">2024-12-31T03:46:22Z</dcterms:modified>
</cp:coreProperties>
</file>